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4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 24">
            <a:extLst>
              <a:ext uri="{FF2B5EF4-FFF2-40B4-BE49-F238E27FC236}">
                <a16:creationId xmlns:a16="http://schemas.microsoft.com/office/drawing/2014/main" id="{CED34510-37D9-3F14-9ADE-500C5A0CC84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1742" y="1233088"/>
            <a:ext cx="1739337" cy="1908000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B685DCF9-9851-733C-EC14-E7291D2A3800}"/>
              </a:ext>
            </a:extLst>
          </p:cNvPr>
          <p:cNvSpPr txBox="1"/>
          <p:nvPr/>
        </p:nvSpPr>
        <p:spPr>
          <a:xfrm>
            <a:off x="2317156" y="278959"/>
            <a:ext cx="222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grpSp>
        <p:nvGrpSpPr>
          <p:cNvPr id="27" name="Groupe 26">
            <a:extLst>
              <a:ext uri="{FF2B5EF4-FFF2-40B4-BE49-F238E27FC236}">
                <a16:creationId xmlns:a16="http://schemas.microsoft.com/office/drawing/2014/main" id="{5762A8EC-26B7-E600-ACF2-76FBDCF97B67}"/>
              </a:ext>
            </a:extLst>
          </p:cNvPr>
          <p:cNvGrpSpPr/>
          <p:nvPr/>
        </p:nvGrpSpPr>
        <p:grpSpPr>
          <a:xfrm>
            <a:off x="297851" y="940683"/>
            <a:ext cx="3895678" cy="2324695"/>
            <a:chOff x="297851" y="784461"/>
            <a:chExt cx="3895678" cy="2324695"/>
          </a:xfrm>
        </p:grpSpPr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E8ADEBCE-7056-2DE2-4E63-AD2BA2C054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303620" y="1266269"/>
              <a:ext cx="1783892" cy="1620000"/>
            </a:xfrm>
            <a:prstGeom prst="rect">
              <a:avLst/>
            </a:prstGeom>
          </p:spPr>
        </p:pic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565BD3C8-5A5A-73F4-0466-CF5FA80981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55194" y="1266269"/>
              <a:ext cx="1698153" cy="1620000"/>
            </a:xfrm>
            <a:prstGeom prst="rect">
              <a:avLst/>
            </a:prstGeom>
          </p:spPr>
        </p:pic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EDF4A54D-4B54-1812-5EE2-65647EFAA723}"/>
                </a:ext>
              </a:extLst>
            </p:cNvPr>
            <p:cNvSpPr txBox="1"/>
            <p:nvPr/>
          </p:nvSpPr>
          <p:spPr>
            <a:xfrm>
              <a:off x="631579" y="784461"/>
              <a:ext cx="167204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1000" b="1" dirty="0">
                  <a:solidFill>
                    <a:srgbClr val="00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91-PL</a:t>
              </a:r>
            </a:p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infected &amp; 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ducing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60373117-CDF4-6F94-59BF-84925497096C}"/>
                </a:ext>
              </a:extLst>
            </p:cNvPr>
            <p:cNvSpPr txBox="1"/>
            <p:nvPr/>
          </p:nvSpPr>
          <p:spPr>
            <a:xfrm>
              <a:off x="2197603" y="784461"/>
              <a:ext cx="1995926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1000" b="1" dirty="0">
                  <a:solidFill>
                    <a:srgbClr val="8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8166</a:t>
              </a:r>
            </a:p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infected &amp; non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ducing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32" name="Connecteur droit avec flèche 31">
              <a:extLst>
                <a:ext uri="{FF2B5EF4-FFF2-40B4-BE49-F238E27FC236}">
                  <a16:creationId xmlns:a16="http://schemas.microsoft.com/office/drawing/2014/main" id="{8DE3C1DF-78FC-9B2F-BF36-F59E3712B5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0961" y="1853680"/>
              <a:ext cx="0" cy="11398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8D854EA7-39F3-83CA-4138-62FD804C3F18}"/>
                </a:ext>
              </a:extLst>
            </p:cNvPr>
            <p:cNvSpPr txBox="1"/>
            <p:nvPr/>
          </p:nvSpPr>
          <p:spPr>
            <a:xfrm rot="16200000">
              <a:off x="197183" y="1562569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D4F9606E-7FFA-2E6C-ACB7-73DC7AE5BD57}"/>
                </a:ext>
              </a:extLst>
            </p:cNvPr>
            <p:cNvSpPr txBox="1"/>
            <p:nvPr/>
          </p:nvSpPr>
          <p:spPr>
            <a:xfrm>
              <a:off x="1467599" y="2862935"/>
              <a:ext cx="7684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Gag p19</a:t>
              </a:r>
            </a:p>
          </p:txBody>
        </p:sp>
        <p:cxnSp>
          <p:nvCxnSpPr>
            <p:cNvPr id="35" name="Connecteur droit avec flèche 34">
              <a:extLst>
                <a:ext uri="{FF2B5EF4-FFF2-40B4-BE49-F238E27FC236}">
                  <a16:creationId xmlns:a16="http://schemas.microsoft.com/office/drawing/2014/main" id="{5EFC1B78-FFEF-E6DA-3C49-9E45AF08CBFE}"/>
                </a:ext>
              </a:extLst>
            </p:cNvPr>
            <p:cNvCxnSpPr>
              <a:cxnSpLocks/>
            </p:cNvCxnSpPr>
            <p:nvPr/>
          </p:nvCxnSpPr>
          <p:spPr>
            <a:xfrm>
              <a:off x="429349" y="2993556"/>
              <a:ext cx="103825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CEFC1DEC-CA13-2202-B53C-CC370336949D}"/>
                </a:ext>
              </a:extLst>
            </p:cNvPr>
            <p:cNvSpPr txBox="1"/>
            <p:nvPr/>
          </p:nvSpPr>
          <p:spPr>
            <a:xfrm>
              <a:off x="1542606" y="1611466"/>
              <a:ext cx="54534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.1%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D80DB6A-E0F8-40CE-C9A3-7712F329D18D}"/>
                </a:ext>
              </a:extLst>
            </p:cNvPr>
            <p:cNvSpPr txBox="1"/>
            <p:nvPr/>
          </p:nvSpPr>
          <p:spPr>
            <a:xfrm>
              <a:off x="3292066" y="1607459"/>
              <a:ext cx="54534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66%</a:t>
              </a:r>
            </a:p>
          </p:txBody>
        </p:sp>
      </p:grpSp>
      <p:sp>
        <p:nvSpPr>
          <p:cNvPr id="38" name="ZoneTexte 37">
            <a:extLst>
              <a:ext uri="{FF2B5EF4-FFF2-40B4-BE49-F238E27FC236}">
                <a16:creationId xmlns:a16="http://schemas.microsoft.com/office/drawing/2014/main" id="{1681E62C-DEF2-0CC9-E1E2-51E7DFD556B7}"/>
              </a:ext>
            </a:extLst>
          </p:cNvPr>
          <p:cNvSpPr txBox="1"/>
          <p:nvPr/>
        </p:nvSpPr>
        <p:spPr>
          <a:xfrm>
            <a:off x="5338485" y="1191659"/>
            <a:ext cx="6880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ag p19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53CFD6A5-5285-AB20-A307-24FAA3F0A6BF}"/>
              </a:ext>
            </a:extLst>
          </p:cNvPr>
          <p:cNvSpPr txBox="1"/>
          <p:nvPr/>
        </p:nvSpPr>
        <p:spPr>
          <a:xfrm>
            <a:off x="5841732" y="235133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gt;0.9999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CE5AEB36-1ECB-9CC0-D56E-946084301FFF}"/>
              </a:ext>
            </a:extLst>
          </p:cNvPr>
          <p:cNvSpPr txBox="1"/>
          <p:nvPr/>
        </p:nvSpPr>
        <p:spPr>
          <a:xfrm>
            <a:off x="5498044" y="1516793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13C5D23F-DEF0-2A28-7F7C-30398C36352E}"/>
              </a:ext>
            </a:extLst>
          </p:cNvPr>
          <p:cNvSpPr txBox="1"/>
          <p:nvPr/>
        </p:nvSpPr>
        <p:spPr>
          <a:xfrm>
            <a:off x="429349" y="3578147"/>
            <a:ext cx="604061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6. Viral capture in MDDCs cocultured with C91-PL or C8166 T cell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Viral capture in MDDCs cocultured with C91-PL or C8166 T cells was assessed after 24h of coculture by Gag p19 staining on CD11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DCs. The percentage of Gag p19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DCs among total CD11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DCs was determined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: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presentative experiment.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: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sults from n=14 independent experiments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ata wer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alysed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ith Friedman test, as presented in Supplementary Table 8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/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5AC36D21-9ABD-595E-661B-A865B4610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3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3</TotalTime>
  <Words>121</Words>
  <Application>Microsoft Macintosh PowerPoint</Application>
  <PresentationFormat>Format A4 (210 x 297 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5</cp:revision>
  <cp:lastPrinted>2024-05-03T15:39:09Z</cp:lastPrinted>
  <dcterms:created xsi:type="dcterms:W3CDTF">2023-02-24T13:22:32Z</dcterms:created>
  <dcterms:modified xsi:type="dcterms:W3CDTF">2024-05-06T10:08:32Z</dcterms:modified>
  <cp:category/>
</cp:coreProperties>
</file>